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A8B7D0-A3D5-401A-A9E9-37723A396E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9E7920-8AD6-4B10-900F-862DC54D3E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609ACC-7322-4E8C-909B-5CD468498B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0F20D-2067-4495-9C04-2AF91A0957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9205E7-07EA-4271-B782-85E868909E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5CD08-C86F-4B9F-AA89-D09E719F2B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BA377-D298-4D6A-B37D-8EE458AB31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E90D6A-8F45-4EF3-BF90-7149BB80E5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264161-A026-4D85-B0DB-6A50CF3E32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06954C-9594-44F7-A8C8-C73BD939F9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D83BEF-C278-44B2-BCD7-7BF01023DF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94CD69-8756-40A9-B092-5BC979FDFD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138F92-F208-4D06-9A08-1FAEFD9B7227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3"/>
          <p:cNvSpPr/>
          <p:nvPr/>
        </p:nvSpPr>
        <p:spPr>
          <a:xfrm>
            <a:off x="785880" y="5715000"/>
            <a:ext cx="7848360" cy="198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4A  Schematic chromosomal components of NILs revealed by SSR markers in the region of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TOC.A7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d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rs indicate the homozygous of Tapidor alleles. The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lue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rs indicate the homozygous of Ningyou7 alleles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组合 22"/>
          <p:cNvGrpSpPr/>
          <p:nvPr/>
        </p:nvGrpSpPr>
        <p:grpSpPr>
          <a:xfrm>
            <a:off x="252360" y="357120"/>
            <a:ext cx="8891640" cy="5388120"/>
            <a:chOff x="252360" y="357120"/>
            <a:chExt cx="8891640" cy="5388120"/>
          </a:xfrm>
        </p:grpSpPr>
        <p:grpSp>
          <p:nvGrpSpPr>
            <p:cNvPr id="43" name="组合 6"/>
            <p:cNvGrpSpPr/>
            <p:nvPr/>
          </p:nvGrpSpPr>
          <p:grpSpPr>
            <a:xfrm>
              <a:off x="252360" y="384840"/>
              <a:ext cx="7849800" cy="5360400"/>
              <a:chOff x="252360" y="384840"/>
              <a:chExt cx="7849800" cy="5360400"/>
            </a:xfrm>
          </p:grpSpPr>
          <p:pic>
            <p:nvPicPr>
              <p:cNvPr id="44" name="Picture 2" descr="C:\Users\IBM\Desktop\无标题.jpg"/>
              <p:cNvPicPr/>
              <p:nvPr/>
            </p:nvPicPr>
            <p:blipFill>
              <a:blip r:embed="rId1"/>
              <a:srcRect l="0" t="0" r="43394" b="0"/>
              <a:stretch/>
            </p:blipFill>
            <p:spPr>
              <a:xfrm>
                <a:off x="252360" y="456840"/>
                <a:ext cx="6573240" cy="5288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TextBox 4"/>
              <p:cNvSpPr/>
              <p:nvPr/>
            </p:nvSpPr>
            <p:spPr>
              <a:xfrm>
                <a:off x="6825600" y="384840"/>
                <a:ext cx="1276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C309-3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TextBox 7"/>
              <p:cNvSpPr/>
              <p:nvPr/>
            </p:nvSpPr>
            <p:spPr>
              <a:xfrm>
                <a:off x="6806160" y="744840"/>
                <a:ext cx="1276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C309-20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TextBox 8"/>
              <p:cNvSpPr/>
              <p:nvPr/>
            </p:nvSpPr>
            <p:spPr>
              <a:xfrm>
                <a:off x="6806160" y="1095480"/>
                <a:ext cx="1276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C309-16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TextBox 9"/>
              <p:cNvSpPr/>
              <p:nvPr/>
            </p:nvSpPr>
            <p:spPr>
              <a:xfrm>
                <a:off x="6806160" y="1455480"/>
                <a:ext cx="1276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C309-21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TextBox 10"/>
              <p:cNvSpPr/>
              <p:nvPr/>
            </p:nvSpPr>
            <p:spPr>
              <a:xfrm>
                <a:off x="6806160" y="1743840"/>
                <a:ext cx="1276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C309-9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TextBox 11"/>
              <p:cNvSpPr/>
              <p:nvPr/>
            </p:nvSpPr>
            <p:spPr>
              <a:xfrm>
                <a:off x="6806160" y="2103840"/>
                <a:ext cx="1276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C309-17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TextBox 12"/>
              <p:cNvSpPr/>
              <p:nvPr/>
            </p:nvSpPr>
            <p:spPr>
              <a:xfrm>
                <a:off x="6806160" y="2463840"/>
                <a:ext cx="1276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C309-7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2" name="组合 21"/>
            <p:cNvGrpSpPr/>
            <p:nvPr/>
          </p:nvGrpSpPr>
          <p:grpSpPr>
            <a:xfrm>
              <a:off x="7858080" y="357120"/>
              <a:ext cx="1285920" cy="2409120"/>
              <a:chOff x="7858080" y="357120"/>
              <a:chExt cx="1285920" cy="2409120"/>
            </a:xfrm>
          </p:grpSpPr>
          <p:sp>
            <p:nvSpPr>
              <p:cNvPr id="53" name="TextBox 14"/>
              <p:cNvSpPr/>
              <p:nvPr/>
            </p:nvSpPr>
            <p:spPr>
              <a:xfrm>
                <a:off x="7867080" y="2428920"/>
                <a:ext cx="127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qTOC.A7-1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TextBox 15"/>
              <p:cNvSpPr/>
              <p:nvPr/>
            </p:nvSpPr>
            <p:spPr>
              <a:xfrm>
                <a:off x="7858080" y="2071800"/>
                <a:ext cx="127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qTOC.A7-1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TextBox 16"/>
              <p:cNvSpPr/>
              <p:nvPr/>
            </p:nvSpPr>
            <p:spPr>
              <a:xfrm>
                <a:off x="7858080" y="1714320"/>
                <a:ext cx="127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qTOC.A7-1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TextBox 17"/>
              <p:cNvSpPr/>
              <p:nvPr/>
            </p:nvSpPr>
            <p:spPr>
              <a:xfrm>
                <a:off x="7858080" y="1428480"/>
                <a:ext cx="127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qTOC.A7-2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TextBox 18"/>
              <p:cNvSpPr/>
              <p:nvPr/>
            </p:nvSpPr>
            <p:spPr>
              <a:xfrm>
                <a:off x="7858080" y="1071360"/>
                <a:ext cx="127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qTOC.A7-3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TextBox 19"/>
              <p:cNvSpPr/>
              <p:nvPr/>
            </p:nvSpPr>
            <p:spPr>
              <a:xfrm>
                <a:off x="7858080" y="714240"/>
                <a:ext cx="127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qTOC.A7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TextBox 20"/>
              <p:cNvSpPr/>
              <p:nvPr/>
            </p:nvSpPr>
            <p:spPr>
              <a:xfrm>
                <a:off x="7858080" y="357120"/>
                <a:ext cx="1276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qTOC.A7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8"/>
          <p:cNvSpPr/>
          <p:nvPr/>
        </p:nvSpPr>
        <p:spPr>
          <a:xfrm>
            <a:off x="785880" y="5500800"/>
            <a:ext cx="7848360" cy="198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4B Schematic chromosomal components of NILs revealed by SSR markers in the region of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TOC.A9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d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rs indicate the homozygous of Tapidor alleles. The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lue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rs indicate the homozygous of Ningyou7 alleles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1" name="组合 15"/>
          <p:cNvGrpSpPr/>
          <p:nvPr/>
        </p:nvGrpSpPr>
        <p:grpSpPr>
          <a:xfrm>
            <a:off x="247680" y="642960"/>
            <a:ext cx="9110520" cy="4514760"/>
            <a:chOff x="247680" y="642960"/>
            <a:chExt cx="9110520" cy="4514760"/>
          </a:xfrm>
        </p:grpSpPr>
        <p:grpSp>
          <p:nvGrpSpPr>
            <p:cNvPr id="62" name="组合 2"/>
            <p:cNvGrpSpPr/>
            <p:nvPr/>
          </p:nvGrpSpPr>
          <p:grpSpPr>
            <a:xfrm>
              <a:off x="247680" y="692640"/>
              <a:ext cx="7924680" cy="4465080"/>
              <a:chOff x="247680" y="692640"/>
              <a:chExt cx="7924680" cy="4465080"/>
            </a:xfrm>
          </p:grpSpPr>
          <p:pic>
            <p:nvPicPr>
              <p:cNvPr id="63" name="Picture 2" descr="C:\Users\IBM\Desktop\NIL9-1.jpg"/>
              <p:cNvPicPr/>
              <p:nvPr/>
            </p:nvPicPr>
            <p:blipFill>
              <a:blip r:embed="rId1"/>
              <a:srcRect l="0" t="0" r="32655" b="24578"/>
              <a:stretch/>
            </p:blipFill>
            <p:spPr>
              <a:xfrm>
                <a:off x="247680" y="764640"/>
                <a:ext cx="6700680" cy="4393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4" name="TextBox 1"/>
              <p:cNvSpPr/>
              <p:nvPr/>
            </p:nvSpPr>
            <p:spPr>
              <a:xfrm>
                <a:off x="7092360" y="692640"/>
                <a:ext cx="1080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C37-5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TextBox 3"/>
              <p:cNvSpPr/>
              <p:nvPr/>
            </p:nvSpPr>
            <p:spPr>
              <a:xfrm>
                <a:off x="7092360" y="980640"/>
                <a:ext cx="1080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C36-9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TextBox 4"/>
              <p:cNvSpPr/>
              <p:nvPr/>
            </p:nvSpPr>
            <p:spPr>
              <a:xfrm>
                <a:off x="7092360" y="1331280"/>
                <a:ext cx="1080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C51-2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TextBox 5"/>
              <p:cNvSpPr/>
              <p:nvPr/>
            </p:nvSpPr>
            <p:spPr>
              <a:xfrm>
                <a:off x="7092360" y="1619640"/>
                <a:ext cx="1080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C45-10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TextBox 6"/>
              <p:cNvSpPr/>
              <p:nvPr/>
            </p:nvSpPr>
            <p:spPr>
              <a:xfrm>
                <a:off x="7092360" y="1979640"/>
                <a:ext cx="1080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C57-7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9" name="组合 14"/>
            <p:cNvGrpSpPr/>
            <p:nvPr/>
          </p:nvGrpSpPr>
          <p:grpSpPr>
            <a:xfrm>
              <a:off x="7858080" y="642960"/>
              <a:ext cx="1500120" cy="1641960"/>
              <a:chOff x="7858080" y="642960"/>
              <a:chExt cx="1500120" cy="1641960"/>
            </a:xfrm>
          </p:grpSpPr>
          <p:sp>
            <p:nvSpPr>
              <p:cNvPr id="70" name="TextBox 9"/>
              <p:cNvSpPr/>
              <p:nvPr/>
            </p:nvSpPr>
            <p:spPr>
              <a:xfrm>
                <a:off x="7858080" y="1947600"/>
                <a:ext cx="14194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qTOC.A9-1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TextBox 10"/>
              <p:cNvSpPr/>
              <p:nvPr/>
            </p:nvSpPr>
            <p:spPr>
              <a:xfrm>
                <a:off x="7929360" y="1590120"/>
                <a:ext cx="13482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qTOC.A9-2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TextBox 11"/>
              <p:cNvSpPr/>
              <p:nvPr/>
            </p:nvSpPr>
            <p:spPr>
              <a:xfrm>
                <a:off x="7858080" y="1285920"/>
                <a:ext cx="15001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</a:t>
                </a:r>
                <a:r>
                  <a:rPr b="1" i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qTOC.A9-3,4,5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TextBox 12"/>
              <p:cNvSpPr/>
              <p:nvPr/>
            </p:nvSpPr>
            <p:spPr>
              <a:xfrm>
                <a:off x="8000640" y="928440"/>
                <a:ext cx="12765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qTOC.A9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TextBox 13"/>
              <p:cNvSpPr/>
              <p:nvPr/>
            </p:nvSpPr>
            <p:spPr>
              <a:xfrm>
                <a:off x="8000640" y="642960"/>
                <a:ext cx="12765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i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qTOC.A9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07T06:44:34Z</dcterms:created>
  <dc:creator>Star</dc:creator>
  <dc:description/>
  <dc:language>en-US</dc:language>
  <cp:lastModifiedBy>hp</cp:lastModifiedBy>
  <dcterms:modified xsi:type="dcterms:W3CDTF">2012-06-14T00:18:02Z</dcterms:modified>
  <cp:revision>28</cp:revision>
  <dc:subject/>
  <dc:title>幻灯片 1</dc:title>
</cp:coreProperties>
</file>